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avi" ContentType="video/x-msvide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 showGuides="1">
      <p:cViewPr varScale="1">
        <p:scale>
          <a:sx n="160" d="100"/>
          <a:sy n="160" d="100"/>
        </p:scale>
        <p:origin x="2466" y="13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60CA78-4977-4734-9734-9C54889BFD22}" type="datetimeFigureOut">
              <a:rPr lang="en-US" smtClean="0"/>
              <a:t>3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0CA4E-2FB9-47C8-8D31-1529A724B3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90947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60CA78-4977-4734-9734-9C54889BFD22}" type="datetimeFigureOut">
              <a:rPr lang="en-US" smtClean="0"/>
              <a:t>3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0CA4E-2FB9-47C8-8D31-1529A724B3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20269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60CA78-4977-4734-9734-9C54889BFD22}" type="datetimeFigureOut">
              <a:rPr lang="en-US" smtClean="0"/>
              <a:t>3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0CA4E-2FB9-47C8-8D31-1529A724B3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33106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60CA78-4977-4734-9734-9C54889BFD22}" type="datetimeFigureOut">
              <a:rPr lang="en-US" smtClean="0"/>
              <a:t>3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0CA4E-2FB9-47C8-8D31-1529A724B3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74180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60CA78-4977-4734-9734-9C54889BFD22}" type="datetimeFigureOut">
              <a:rPr lang="en-US" smtClean="0"/>
              <a:t>3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0CA4E-2FB9-47C8-8D31-1529A724B3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337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60CA78-4977-4734-9734-9C54889BFD22}" type="datetimeFigureOut">
              <a:rPr lang="en-US" smtClean="0"/>
              <a:t>3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0CA4E-2FB9-47C8-8D31-1529A724B3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36016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60CA78-4977-4734-9734-9C54889BFD22}" type="datetimeFigureOut">
              <a:rPr lang="en-US" smtClean="0"/>
              <a:t>3/4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0CA4E-2FB9-47C8-8D31-1529A724B3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52493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60CA78-4977-4734-9734-9C54889BFD22}" type="datetimeFigureOut">
              <a:rPr lang="en-US" smtClean="0"/>
              <a:t>3/4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0CA4E-2FB9-47C8-8D31-1529A724B3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95241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60CA78-4977-4734-9734-9C54889BFD22}" type="datetimeFigureOut">
              <a:rPr lang="en-US" smtClean="0"/>
              <a:t>3/4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0CA4E-2FB9-47C8-8D31-1529A724B3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10717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60CA78-4977-4734-9734-9C54889BFD22}" type="datetimeFigureOut">
              <a:rPr lang="en-US" smtClean="0"/>
              <a:t>3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0CA4E-2FB9-47C8-8D31-1529A724B3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89044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60CA78-4977-4734-9734-9C54889BFD22}" type="datetimeFigureOut">
              <a:rPr lang="en-US" smtClean="0"/>
              <a:t>3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0CA4E-2FB9-47C8-8D31-1529A724B3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46354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60CA78-4977-4734-9734-9C54889BFD22}" type="datetimeFigureOut">
              <a:rPr lang="en-US" smtClean="0"/>
              <a:t>3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90CA4E-2FB9-47C8-8D31-1529A724B3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03140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0" y="5873115"/>
            <a:ext cx="12192000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5 Fig</a:t>
            </a:r>
            <a:r>
              <a:rPr lang="en-US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2000" dirty="0">
                <a:latin typeface="Times New Roman" panose="02020603050405020304" pitchFamily="18" charset="0"/>
                <a:ea typeface="Calibri" panose="020F0502020204030204" pitchFamily="34" charset="0"/>
              </a:rPr>
              <a:t>Multiphoton laser-induced TPMD-Ca</a:t>
            </a:r>
            <a:r>
              <a:rPr lang="en-US" sz="20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++</a:t>
            </a:r>
            <a:r>
              <a:rPr lang="en-US" sz="2000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20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Wv</a:t>
            </a:r>
            <a:r>
              <a:rPr lang="en-US" sz="2000" dirty="0">
                <a:latin typeface="Times New Roman" panose="02020603050405020304" pitchFamily="18" charset="0"/>
                <a:ea typeface="Calibri" panose="020F0502020204030204" pitchFamily="34" charset="0"/>
              </a:rPr>
              <a:t> in a living mouse cornea. </a:t>
            </a:r>
            <a:r>
              <a:rPr lang="en-US" dirty="0">
                <a:solidFill>
                  <a:srgbClr val="20202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lcium wave spread among mouse corneal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dirty="0">
                <a:solidFill>
                  <a:srgbClr val="20202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pithelial cells.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ill photos in Fig. 3 a-f captured from this video. </a:t>
            </a:r>
            <a:r>
              <a:rPr lang="en-US" sz="2000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dirty="0">
                <a:solidFill>
                  <a:srgbClr val="20202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ircle highlights the TPMD target on the source cell.</a:t>
            </a:r>
            <a:endParaRPr lang="en-US" dirty="0"/>
          </a:p>
        </p:txBody>
      </p:sp>
      <p:pic>
        <p:nvPicPr>
          <p:cNvPr id="2" name="Supplemental Figure 5 (Fig. 3 a-f) (01032024)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3954807" y="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3146799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4</TotalTime>
  <Words>45</Words>
  <Application>Microsoft Office PowerPoint</Application>
  <PresentationFormat>Widescreen</PresentationFormat>
  <Paragraphs>1</Paragraphs>
  <Slides>1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Augusta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en, Zhong</dc:creator>
  <cp:lastModifiedBy>Chen, Zhong</cp:lastModifiedBy>
  <cp:revision>10</cp:revision>
  <dcterms:created xsi:type="dcterms:W3CDTF">2023-12-19T14:15:37Z</dcterms:created>
  <dcterms:modified xsi:type="dcterms:W3CDTF">2024-03-04T16:42:22Z</dcterms:modified>
</cp:coreProperties>
</file>